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5758FB7-9AC5-4552-8A53-C91805E547FA}" styleName="Style à thème 1 - Accentuation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522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9570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4877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8751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847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2659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2122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4082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35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6146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542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114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863CF-66D6-4D90-93C8-3779DBAACEBA}" type="datetimeFigureOut">
              <a:rPr lang="fr-FR" smtClean="0"/>
              <a:t>21/01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A7993-0016-4AA1-A3BB-BE2641733A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3686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50634" y="6726004"/>
            <a:ext cx="6356733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100" b="1" dirty="0" smtClean="0">
                <a:solidFill>
                  <a:srgbClr val="FF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2</a:t>
            </a:r>
            <a:r>
              <a:rPr lang="en-GB" sz="11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Table. </a:t>
            </a:r>
            <a:r>
              <a:rPr lang="en-GB" sz="1100" b="1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Differential gene expression analysis between </a:t>
            </a:r>
            <a:r>
              <a:rPr lang="en-GB" sz="11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lpha and beta cell </a:t>
            </a:r>
            <a:r>
              <a:rPr lang="en-GB" sz="1100" b="1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types for LFD mice using </a:t>
            </a:r>
            <a:r>
              <a:rPr lang="en-GB" sz="11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DESeq2. 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mRNA levels from LFD mice were evaluated following comparative analysis between control Venus+ alpha </a:t>
            </a:r>
            <a:r>
              <a:rPr lang="en-GB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nd Cherry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+ beta </a:t>
            </a:r>
            <a:r>
              <a:rPr lang="en-GB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cells 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with DESeq2 method (Covariates: GC mean, RIN; Adjusted p value ≤ 0.05). The fold </a:t>
            </a:r>
            <a:r>
              <a:rPr lang="en-GB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gulation 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values represent the ratio of the results obtained </a:t>
            </a:r>
            <a:r>
              <a:rPr lang="en-GB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rom fold change between alpha to 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beta </a:t>
            </a:r>
            <a:r>
              <a:rPr lang="en-GB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cells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. Only the </a:t>
            </a:r>
            <a:r>
              <a:rPr lang="en-GB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15 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most </a:t>
            </a:r>
            <a:r>
              <a:rPr lang="en-GB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enriched expressed 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genes </a:t>
            </a:r>
            <a:r>
              <a:rPr lang="en-GB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in alpha (positive values) and in beta (negative values) are listed (among 6006 differentially expressed genes).</a:t>
            </a:r>
            <a:endParaRPr lang="fr-FR" sz="1100" dirty="0"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leau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8307596"/>
              </p:ext>
            </p:extLst>
          </p:nvPr>
        </p:nvGraphicFramePr>
        <p:xfrm>
          <a:off x="952968" y="599734"/>
          <a:ext cx="4952062" cy="600021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558867">
                  <a:extLst>
                    <a:ext uri="{9D8B030D-6E8A-4147-A177-3AD203B41FA5}">
                      <a16:colId xmlns:a16="http://schemas.microsoft.com/office/drawing/2014/main" val="4230934036"/>
                    </a:ext>
                  </a:extLst>
                </a:gridCol>
                <a:gridCol w="1806767">
                  <a:extLst>
                    <a:ext uri="{9D8B030D-6E8A-4147-A177-3AD203B41FA5}">
                      <a16:colId xmlns:a16="http://schemas.microsoft.com/office/drawing/2014/main" val="2770705149"/>
                    </a:ext>
                  </a:extLst>
                </a:gridCol>
                <a:gridCol w="1586428">
                  <a:extLst>
                    <a:ext uri="{9D8B030D-6E8A-4147-A177-3AD203B41FA5}">
                      <a16:colId xmlns:a16="http://schemas.microsoft.com/office/drawing/2014/main" val="1991746761"/>
                    </a:ext>
                  </a:extLst>
                </a:gridCol>
              </a:tblGrid>
              <a:tr h="167273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</a:t>
                      </a:r>
                      <a:r>
                        <a:rPr lang="fr-FR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  <a:endParaRPr lang="fr-FR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b"/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d</a:t>
                      </a:r>
                      <a:r>
                        <a:rPr lang="fr-FR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ulation</a:t>
                      </a:r>
                      <a:endParaRPr lang="fr-FR" sz="1100" b="1" u="none" strike="noStrike" baseline="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b"/>
                      <a:r>
                        <a:rPr lang="fr-FR" sz="1100" b="1" u="none" strike="noStrike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/</a:t>
                      </a:r>
                      <a:r>
                        <a:rPr lang="fr-FR" sz="1100" b="1" u="none" strike="noStrike" baseline="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d</a:t>
                      </a:r>
                      <a:r>
                        <a:rPr lang="fr-FR" sz="1100" b="1" u="none" strike="noStrike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hange)</a:t>
                      </a:r>
                      <a:endParaRPr lang="fr-FR" sz="1100" b="1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b"/>
                      <a:r>
                        <a:rPr lang="fr-FR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ha vs Beta</a:t>
                      </a:r>
                      <a:endParaRPr lang="fr-FR" sz="1100" b="1" u="none" strike="noStrike" baseline="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0" marR="5180" marT="518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usted</a:t>
                      </a:r>
                      <a:r>
                        <a:rPr lang="fr-FR" sz="1100" b="1" u="none" strike="noStrike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-v</a:t>
                      </a:r>
                      <a:r>
                        <a:rPr lang="fr-FR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ue</a:t>
                      </a:r>
                      <a:endParaRPr lang="fr-FR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0" marR="5180" marT="5180" marB="0" anchor="ctr"/>
                </a:tc>
                <a:extLst>
                  <a:ext uri="{0D108BD9-81ED-4DB2-BD59-A6C34878D82A}">
                    <a16:rowId xmlns:a16="http://schemas.microsoft.com/office/drawing/2014/main" val="3189259142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x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4.43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2E-6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74707877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x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7.88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4E-1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25255438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p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2.33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8E-2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6728614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nt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9.0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4E-2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07331481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tr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5.36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5E-3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88445871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g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1.34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E-2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2018597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7.4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3E-2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07036385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u6f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4.8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7E-3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59633306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pr1b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2.28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4E-2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09308907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h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6.07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8E-3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98686823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d1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2.45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0E-1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65078261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k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.0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1E-3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1702723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i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0.9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0E-1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06313993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6.5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4E-1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3386007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k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5.42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5E-1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397916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80" marR="5180" marT="518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8380428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d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4.54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98E-12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74938273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am151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5.58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80E-2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4508167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rss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6.1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28E-11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63511806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00002J24Rik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78.25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36E-2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2949250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ns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92.4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65E-2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00080102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pp1r1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95.0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.49E-2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66561613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x6a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97.0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.87E-2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31694902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ace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04.69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79E-10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01868902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prm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08.38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.82E-5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77384994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m479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16.97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.13E-2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61439574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rpm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22.79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64E-4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45562904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sl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31.60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6E-2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51156606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cgr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34.36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16E-3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46154661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cn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38.14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45E-4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31330704"/>
                  </a:ext>
                </a:extLst>
              </a:tr>
              <a:tr h="167273">
                <a:tc>
                  <a:txBody>
                    <a:bodyPr/>
                    <a:lstStyle/>
                    <a:p>
                      <a:pPr algn="ctr" fontAlgn="b"/>
                      <a:r>
                        <a:rPr lang="fr-CH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sb11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H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76.07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19E-6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747861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930538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99</TotalTime>
  <Words>226</Words>
  <Application>Microsoft Office PowerPoint</Application>
  <PresentationFormat>Affichage à l'écran (4:3)</PresentationFormat>
  <Paragraphs>9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Thème Office</vt:lpstr>
      <vt:lpstr>Présentation PowerPoint</vt:lpstr>
    </vt:vector>
  </TitlesOfParts>
  <Company>Uni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van Gosmain</dc:creator>
  <cp:lastModifiedBy>Rodolphe Dusaulcy</cp:lastModifiedBy>
  <cp:revision>181</cp:revision>
  <cp:lastPrinted>2018-10-26T15:14:21Z</cp:lastPrinted>
  <dcterms:created xsi:type="dcterms:W3CDTF">2018-03-28T11:59:25Z</dcterms:created>
  <dcterms:modified xsi:type="dcterms:W3CDTF">2019-01-21T15:59:51Z</dcterms:modified>
</cp:coreProperties>
</file>